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9" r:id="rId3"/>
    <p:sldId id="260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69" d="100"/>
          <a:sy n="69" d="100"/>
        </p:scale>
        <p:origin x="49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6C0B3C-39F3-F160-6434-88709DE48AF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2DFB8EC-4A51-A846-98FD-B5086378649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F7F254D-9CBC-7A8D-5128-E3EF053727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560E6-75DD-4A9C-895B-CA56BF4027D2}" type="datetimeFigureOut">
              <a:rPr lang="en-US" smtClean="0"/>
              <a:t>3/2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AB0BE06-FEE8-ED6A-CBB6-E424363BEF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96093C0-CD13-6A8A-E75A-4EAB191890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19C61-421E-4711-8430-EFD1A85A96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97071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8B670E-98B8-0E1F-99A7-073E7D0E4F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8ABB08F-FAF9-ABDB-98A7-E59A4EE838F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8946507-A066-C198-DBCA-071D051EBC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560E6-75DD-4A9C-895B-CA56BF4027D2}" type="datetimeFigureOut">
              <a:rPr lang="en-US" smtClean="0"/>
              <a:t>3/2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A82BF55-6ABF-DD90-82A7-F58CDC2B7F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D1587C-1403-5DD1-A9AB-447EBF2F98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19C61-421E-4711-8430-EFD1A85A96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34754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C92DC36-D7C5-FF3B-521F-BA7626F57AB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A1758C2-65D5-3C98-26D2-43ADDF5BAE6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41CDDC9-509F-A8CF-8937-8FE84E0B7D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560E6-75DD-4A9C-895B-CA56BF4027D2}" type="datetimeFigureOut">
              <a:rPr lang="en-US" smtClean="0"/>
              <a:t>3/2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5E1C60B-3555-8F26-C657-E6327DC18B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90D430-82B1-7357-77AB-5287567750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19C61-421E-4711-8430-EFD1A85A96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87857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C02352-FF4B-D161-497A-AF23201999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8EA9776-07BA-FC38-066B-C2A95E3E8EA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803ECA6-4DED-C0E5-ECEC-0899854C76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560E6-75DD-4A9C-895B-CA56BF4027D2}" type="datetimeFigureOut">
              <a:rPr lang="en-US" smtClean="0"/>
              <a:t>3/2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4B0680-A607-A6A2-A839-E5D9DF40D3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47F63D-3B94-4B15-7A38-2669CAEF9A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19C61-421E-4711-8430-EFD1A85A96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50582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674E01-4206-5D89-9760-950B63DFD4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822E062-F534-470D-5CF7-B424B22416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568F32-B56E-8102-0602-EF76ACE035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560E6-75DD-4A9C-895B-CA56BF4027D2}" type="datetimeFigureOut">
              <a:rPr lang="en-US" smtClean="0"/>
              <a:t>3/2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1579860-57BF-1E8E-0D1C-10D69269E0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538DABF-9B41-0A9D-E598-CEF4BFDE29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19C61-421E-4711-8430-EFD1A85A96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20475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C55B73-0438-830D-D3B8-AEE65F4620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6477AE5-8FF5-7A0B-7D30-BE678DB1AF0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169C8C2-55B1-2EA0-1A96-AC3710E5E57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612AD62-D474-31A5-D98E-D6717888F8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560E6-75DD-4A9C-895B-CA56BF4027D2}" type="datetimeFigureOut">
              <a:rPr lang="en-US" smtClean="0"/>
              <a:t>3/27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67BEC99-DD01-AAB8-C0C4-B84D550DAE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61ADF9F-FE33-2D11-CBCF-8F0B98C0BB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19C61-421E-4711-8430-EFD1A85A96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38214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314910-ED7F-8104-E992-6073E9EE17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D916903-EDAE-35E0-9871-034F3D0BA52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CB5E671-ED53-4ACF-E077-0A36C4BEE46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65C603B-128F-8764-EFCC-52E64A6C6B0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C393ED3-E81F-8010-FCAB-ED9FCD793D1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26E81D6-1815-A8EE-491D-49860CDA8D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560E6-75DD-4A9C-895B-CA56BF4027D2}" type="datetimeFigureOut">
              <a:rPr lang="en-US" smtClean="0"/>
              <a:t>3/27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1E4EB2D-3FD1-CA11-AF2C-0CE8FD10AD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3801C3B-7F0C-AE86-BC78-692F05473C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19C61-421E-4711-8430-EFD1A85A96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09175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73C52A-DC93-5C6A-6038-9D6E92DDFE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5ABFA44-87D6-0A8E-48CD-AC5A631E9B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560E6-75DD-4A9C-895B-CA56BF4027D2}" type="datetimeFigureOut">
              <a:rPr lang="en-US" smtClean="0"/>
              <a:t>3/27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47A996A-2BE9-A418-8AD4-0E7F41C751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61D7905-0B5D-D73F-4832-C603C9489B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19C61-421E-4711-8430-EFD1A85A96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67091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0146F92-25A9-EFA9-62F9-D66FF49AE4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560E6-75DD-4A9C-895B-CA56BF4027D2}" type="datetimeFigureOut">
              <a:rPr lang="en-US" smtClean="0"/>
              <a:t>3/27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1F2538F-26C9-ECF9-EBFA-65BE72567D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AF9C1B4-4CF4-6EE7-E560-9961456283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19C61-421E-4711-8430-EFD1A85A96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86255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1FAEBD-D876-8638-55D9-0EADFE1649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7491407-3163-138D-853E-06965B0606A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35A029B-B0F6-AF64-8290-26B851B2C38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DED3FBA-45D0-6DD1-44EA-A54CB6FA33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560E6-75DD-4A9C-895B-CA56BF4027D2}" type="datetimeFigureOut">
              <a:rPr lang="en-US" smtClean="0"/>
              <a:t>3/27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860FFA8-E040-26B0-6B8B-718B9C3FE3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04B0437-2719-1AD6-735B-D8D373AD99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19C61-421E-4711-8430-EFD1A85A96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00901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D2F734-1B5B-5F1E-924B-F83D46246B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9A37697-550B-BE9C-EA42-D5509463132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144D4E0-E9E7-4A88-5E7D-B7A3E48B109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A908004-358B-FE03-9305-39B0283418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560E6-75DD-4A9C-895B-CA56BF4027D2}" type="datetimeFigureOut">
              <a:rPr lang="en-US" smtClean="0"/>
              <a:t>3/27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53E006F-78B4-0E0B-FF1C-BBEF822B46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9D3438B-A090-7FEE-9CEB-E13562A0D8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19C61-421E-4711-8430-EFD1A85A96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1662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1FB1D4A-0B76-1DE3-830B-3C339D3A9A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DBD7CB7-79C9-C558-9369-FC14024D12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C4B6E7-B430-0DD3-EFCE-272E10AEB1A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1560E6-75DD-4A9C-895B-CA56BF4027D2}" type="datetimeFigureOut">
              <a:rPr lang="en-US" smtClean="0"/>
              <a:t>3/2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AD45310-B8D1-9DFF-7745-8BA00287DF3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6115A3-B923-237A-3BD1-7718B4CDD6D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F19C61-421E-4711-8430-EFD1A85A96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26074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hyperlink" Target="http://slorth.biochem.sussex.ac.uk/welcome/index" TargetMode="Externa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2F17D3-1BA6-B65D-9FDA-9D410CBAFD7B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Supplementary Figures</a:t>
            </a:r>
            <a:br>
              <a:rPr lang="en-US" dirty="0"/>
            </a:br>
            <a:endParaRPr lang="en-US" dirty="0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E445328-E5E6-85D7-E367-314F471C20BB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ticancer efficacy of KRASG12C inhibitors is potentiated by PAK4 inhibitor KPT9274 in preclinical models of KRASG12C mutant pancreatic and lung cancers 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283259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0EE79974-39F1-DF95-50EE-F5BA9850C36F}"/>
              </a:ext>
            </a:extLst>
          </p:cNvPr>
          <p:cNvGrpSpPr/>
          <p:nvPr/>
        </p:nvGrpSpPr>
        <p:grpSpPr>
          <a:xfrm>
            <a:off x="0" y="0"/>
            <a:ext cx="12329827" cy="6723552"/>
            <a:chOff x="0" y="0"/>
            <a:chExt cx="12329827" cy="6723552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D836DB32-6593-E9A1-A4EC-30D2C73CFC6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1742" t="14680" r="13333" b="10707"/>
            <a:stretch/>
          </p:blipFill>
          <p:spPr>
            <a:xfrm>
              <a:off x="852547" y="548731"/>
              <a:ext cx="10283706" cy="5760539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9B8DC651-F390-E7F6-3301-D5D92F2F4E0E}"/>
                </a:ext>
              </a:extLst>
            </p:cNvPr>
            <p:cNvSpPr txBox="1"/>
            <p:nvPr/>
          </p:nvSpPr>
          <p:spPr>
            <a:xfrm>
              <a:off x="149664" y="6354220"/>
              <a:ext cx="12180163" cy="369332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Times New Roman" panose="02020603050405020304" pitchFamily="18" charset="0"/>
                  <a:ea typeface="Calibri" panose="020F0502020204030204" pitchFamily="34" charset="0"/>
                </a:rPr>
                <a:t>PAK4</a:t>
              </a:r>
              <a:r>
                <a:rPr lang="en-US" sz="18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</a:rPr>
                <a:t>-KRAS synthetic lethal interaction identified using the </a:t>
              </a:r>
              <a:r>
                <a:rPr lang="en-US" sz="1800" dirty="0" err="1">
                  <a:effectLst/>
                  <a:latin typeface="Times New Roman" panose="02020603050405020304" pitchFamily="18" charset="0"/>
                  <a:ea typeface="Calibri" panose="020F0502020204030204" pitchFamily="34" charset="0"/>
                </a:rPr>
                <a:t>Slorth</a:t>
              </a:r>
              <a:r>
                <a:rPr lang="en-US" sz="18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</a:rPr>
                <a:t> database (</a:t>
              </a:r>
              <a:r>
                <a:rPr lang="en-US" sz="1800" u="sng" dirty="0">
                  <a:solidFill>
                    <a:srgbClr val="0563C1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hlinkClick r:id="rId3"/>
                </a:rPr>
                <a:t>http://slorth.biochem.sussex.ac.uk/welcome/index</a:t>
              </a:r>
              <a:r>
                <a:rPr lang="en-US" sz="1800" u="sng" dirty="0">
                  <a:solidFill>
                    <a:srgbClr val="0563C1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</a:rPr>
                <a:t>)</a:t>
              </a:r>
              <a:endParaRPr lang="en-US" dirty="0"/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FE445B07-BC8A-4CEC-23F9-8EB459ED3D53}"/>
                </a:ext>
              </a:extLst>
            </p:cNvPr>
            <p:cNvSpPr txBox="1"/>
            <p:nvPr/>
          </p:nvSpPr>
          <p:spPr>
            <a:xfrm>
              <a:off x="0" y="0"/>
              <a:ext cx="290675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Figure 1.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60337100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FD969987-6B6E-89A5-6C55-3A5B4C647D2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32977" y="853346"/>
            <a:ext cx="6704373" cy="4466643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BB5BA236-9C62-AE8F-05CA-1CE65E7C7490}"/>
              </a:ext>
            </a:extLst>
          </p:cNvPr>
          <p:cNvSpPr txBox="1"/>
          <p:nvPr/>
        </p:nvSpPr>
        <p:spPr>
          <a:xfrm>
            <a:off x="0" y="0"/>
            <a:ext cx="29067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0439350-EB3E-FA6C-34B6-E18DC6407C0D}"/>
              </a:ext>
            </a:extLst>
          </p:cNvPr>
          <p:cNvSpPr txBox="1"/>
          <p:nvPr/>
        </p:nvSpPr>
        <p:spPr>
          <a:xfrm>
            <a:off x="571499" y="5551556"/>
            <a:ext cx="11140209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defTabSz="169347"/>
            <a:r>
              <a:rPr lang="en-US" b="1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2</a:t>
            </a:r>
            <a:r>
              <a:rPr lang="en-US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Synergistic inhibition of cell proliferation, as indicated by CI values &lt; 1, was achieved when 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RAS</a:t>
            </a:r>
            <a:r>
              <a:rPr lang="en-US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12C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mutant MEFs </a:t>
            </a:r>
            <a:r>
              <a:rPr lang="en-US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RAS 4B G12C (</a:t>
            </a:r>
            <a:r>
              <a:rPr lang="en-US" b="1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were treated with KPT9274 and MRTX849 at three different dose combinations. Such synergistic effects were not observed with the 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RAS</a:t>
            </a:r>
            <a:r>
              <a:rPr lang="en-US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12D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mutant </a:t>
            </a:r>
            <a:r>
              <a:rPr lang="en-US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RAS 4B G12D cells (</a:t>
            </a:r>
            <a:r>
              <a:rPr lang="en-US" b="1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dirty="0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</a:t>
            </a:r>
            <a:endParaRPr lang="en-US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883834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</TotalTime>
  <Words>117</Words>
  <Application>Microsoft Office PowerPoint</Application>
  <PresentationFormat>Widescreen</PresentationFormat>
  <Paragraphs>6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Supplementary Figures 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s </dc:title>
  <dc:creator>Husain Khan</dc:creator>
  <cp:lastModifiedBy>Husain Khan</cp:lastModifiedBy>
  <cp:revision>3</cp:revision>
  <dcterms:created xsi:type="dcterms:W3CDTF">2023-03-21T07:53:04Z</dcterms:created>
  <dcterms:modified xsi:type="dcterms:W3CDTF">2023-03-27T07:01:41Z</dcterms:modified>
</cp:coreProperties>
</file>